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47758E-5F18-46C6-A3DE-856A252B50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5657A7-D7CF-4892-98E2-412EC41C4F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38356-2B11-4A0E-9892-300767F9D6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870344-1F58-47C5-A68D-2D232B91DBD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80B01F-3A38-48FF-96EA-F91E29D364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A8754-3C0B-4D4F-BA62-7D3A884FA2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55F9A9-525C-4401-B19C-56297E2F49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8C0F83-6DAF-449A-8056-D58A5C513F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4CF0FC-02B9-484F-9635-363AF41FC3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A012A7-4B9A-4B43-8E93-4D0E7327F8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1996D0-24DC-4610-BBC7-516A18B485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EE3E1C-4C6F-4809-A3B5-BB7511AE45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9FD604-3380-463D-83E3-CA95E3F80FE0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4041720" y="3222720"/>
            <a:ext cx="2590920" cy="19508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tretch/>
        </p:blipFill>
        <p:spPr>
          <a:xfrm>
            <a:off x="353880" y="1100160"/>
            <a:ext cx="2590920" cy="19508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8" descr=""/>
          <p:cNvPicPr/>
          <p:nvPr/>
        </p:nvPicPr>
        <p:blipFill>
          <a:blip r:embed="rId3"/>
          <a:stretch/>
        </p:blipFill>
        <p:spPr>
          <a:xfrm>
            <a:off x="353880" y="3222720"/>
            <a:ext cx="2590920" cy="1950840"/>
          </a:xfrm>
          <a:prstGeom prst="rect">
            <a:avLst/>
          </a:prstGeom>
          <a:ln w="0">
            <a:noFill/>
          </a:ln>
        </p:spPr>
      </p:pic>
      <p:sp>
        <p:nvSpPr>
          <p:cNvPr id="44" name="テキスト ボックス 1"/>
          <p:cNvSpPr/>
          <p:nvPr/>
        </p:nvSpPr>
        <p:spPr>
          <a:xfrm>
            <a:off x="3012120" y="1782720"/>
            <a:ext cx="8575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RN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9"/>
          <p:cNvSpPr/>
          <p:nvPr/>
        </p:nvSpPr>
        <p:spPr>
          <a:xfrm>
            <a:off x="3021840" y="3905280"/>
            <a:ext cx="8146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PARγ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RN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テキスト ボックス 11"/>
          <p:cNvSpPr/>
          <p:nvPr/>
        </p:nvSpPr>
        <p:spPr>
          <a:xfrm>
            <a:off x="1395000" y="5386320"/>
            <a:ext cx="50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テキスト ボックス 12"/>
          <p:cNvSpPr/>
          <p:nvPr/>
        </p:nvSpPr>
        <p:spPr>
          <a:xfrm>
            <a:off x="4689000" y="5386320"/>
            <a:ext cx="1296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fepriston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正方形/長方形 1"/>
          <p:cNvSpPr/>
          <p:nvPr/>
        </p:nvSpPr>
        <p:spPr>
          <a:xfrm>
            <a:off x="347760" y="5878440"/>
            <a:ext cx="6299280" cy="84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Figure S7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Differentiated 3T3-L1 adipocytes had been transiently transfected with control or siRNA targeted to PPARγ 48 hours prior to mifepristone stimulation.  Cells were fixed and observed by microscope (BioRevo, KEYENCE). Bar, 100 microm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直線コネクタ 3"/>
          <p:cNvSpPr/>
          <p:nvPr/>
        </p:nvSpPr>
        <p:spPr>
          <a:xfrm>
            <a:off x="2289240" y="5005440"/>
            <a:ext cx="503280" cy="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11" descr=""/>
          <p:cNvPicPr/>
          <p:nvPr/>
        </p:nvPicPr>
        <p:blipFill>
          <a:blip r:embed="rId4"/>
          <a:stretch/>
        </p:blipFill>
        <p:spPr>
          <a:xfrm>
            <a:off x="4041720" y="1100160"/>
            <a:ext cx="2590920" cy="1950840"/>
          </a:xfrm>
          <a:prstGeom prst="rect">
            <a:avLst/>
          </a:prstGeom>
          <a:ln w="0">
            <a:noFill/>
          </a:ln>
        </p:spPr>
      </p:pic>
      <p:sp>
        <p:nvSpPr>
          <p:cNvPr id="51" name="直線コネクタ 14"/>
          <p:cNvSpPr/>
          <p:nvPr/>
        </p:nvSpPr>
        <p:spPr>
          <a:xfrm>
            <a:off x="2289240" y="2844720"/>
            <a:ext cx="503280" cy="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直線コネクタ 15"/>
          <p:cNvSpPr/>
          <p:nvPr/>
        </p:nvSpPr>
        <p:spPr>
          <a:xfrm>
            <a:off x="5924520" y="5005440"/>
            <a:ext cx="504720" cy="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直線コネクタ 16"/>
          <p:cNvSpPr/>
          <p:nvPr/>
        </p:nvSpPr>
        <p:spPr>
          <a:xfrm>
            <a:off x="5924520" y="2844720"/>
            <a:ext cx="504720" cy="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正方形/長方形 17"/>
          <p:cNvSpPr/>
          <p:nvPr/>
        </p:nvSpPr>
        <p:spPr>
          <a:xfrm>
            <a:off x="392400" y="468360"/>
            <a:ext cx="81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06T06:04:58Z</dcterms:created>
  <dc:creator>Takeshi Hashimoto</dc:creator>
  <dc:description/>
  <dc:language>en-US</dc:language>
  <cp:lastModifiedBy>Physiol2-12</cp:lastModifiedBy>
  <cp:lastPrinted>2013-02-19T23:03:05Z</cp:lastPrinted>
  <dcterms:modified xsi:type="dcterms:W3CDTF">2013-10-20T23:57:43Z</dcterms:modified>
  <cp:revision>443</cp:revision>
  <dc:subject/>
  <dc:title>スライド 1</dc:title>
</cp:coreProperties>
</file>